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7B0101"/>
    <a:srgbClr val="FFC9C2"/>
    <a:srgbClr val="010C9D"/>
    <a:srgbClr val="0110D1"/>
    <a:srgbClr val="AED6F9"/>
    <a:srgbClr val="8C97EC"/>
    <a:srgbClr val="99B2DF"/>
    <a:srgbClr val="E49991"/>
    <a:srgbClr val="950101"/>
    <a:srgbClr val="FFA9A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763"/>
    <p:restoredTop sz="92947"/>
  </p:normalViewPr>
  <p:slideViewPr>
    <p:cSldViewPr snapToGrid="0">
      <p:cViewPr varScale="1">
        <p:scale>
          <a:sx n="69" d="100"/>
          <a:sy n="69" d="100"/>
        </p:scale>
        <p:origin x="764" y="4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5" Type="http://schemas.openxmlformats.org/officeDocument/2006/relationships/chartUserShapes" Target="../drawings/drawing1.xml"/><Relationship Id="rId4" Type="http://schemas.openxmlformats.org/officeDocument/2006/relationships/package" Target="../embeddings/Microsoft_Excel__al__ma_Sayfas_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tr-TR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2791666032074811"/>
          <c:y val="3.2105141269106068E-2"/>
          <c:w val="0.64716306858039141"/>
          <c:h val="0.66409979949808118"/>
        </c:manualLayout>
      </c:layout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dPt>
            <c:idx val="1"/>
            <c:marker>
              <c:symbol val="circle"/>
              <c:size val="5"/>
              <c:spPr>
                <a:solidFill>
                  <a:schemeClr val="accent3"/>
                </a:solidFill>
                <a:ln w="9525">
                  <a:solidFill>
                    <a:schemeClr val="accent3"/>
                  </a:solidFill>
                </a:ln>
                <a:effectLst/>
              </c:spPr>
            </c:marker>
            <c:bubble3D val="0"/>
            <c:spPr>
              <a:ln w="28575" cap="rnd">
                <a:solidFill>
                  <a:schemeClr val="tx1"/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1-1C79-4BED-A6B3-F4FF56ADD96C}"/>
              </c:ext>
            </c:extLst>
          </c:dPt>
          <c:dPt>
            <c:idx val="2"/>
            <c:marker>
              <c:symbol val="circle"/>
              <c:size val="5"/>
              <c:spPr>
                <a:solidFill>
                  <a:schemeClr val="accent3"/>
                </a:solidFill>
                <a:ln w="9525">
                  <a:solidFill>
                    <a:schemeClr val="accent3"/>
                  </a:solidFill>
                </a:ln>
                <a:effectLst/>
              </c:spPr>
            </c:marker>
            <c:bubble3D val="0"/>
            <c:spPr>
              <a:ln w="28575" cap="rnd">
                <a:solidFill>
                  <a:schemeClr val="tx1"/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3-1C79-4BED-A6B3-F4FF56ADD96C}"/>
              </c:ext>
            </c:extLst>
          </c:dPt>
          <c:dPt>
            <c:idx val="3"/>
            <c:marker>
              <c:symbol val="circle"/>
              <c:size val="5"/>
              <c:spPr>
                <a:solidFill>
                  <a:schemeClr val="accent3"/>
                </a:solidFill>
                <a:ln w="9525">
                  <a:solidFill>
                    <a:schemeClr val="accent3"/>
                  </a:solidFill>
                </a:ln>
                <a:effectLst/>
              </c:spPr>
            </c:marker>
            <c:bubble3D val="0"/>
            <c:spPr>
              <a:ln w="28575" cap="rnd">
                <a:solidFill>
                  <a:schemeClr val="tx1"/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5-1C79-4BED-A6B3-F4FF56ADD96C}"/>
              </c:ext>
            </c:extLst>
          </c:dPt>
          <c:dPt>
            <c:idx val="4"/>
            <c:marker>
              <c:symbol val="circle"/>
              <c:size val="5"/>
              <c:spPr>
                <a:solidFill>
                  <a:schemeClr val="accent3"/>
                </a:solidFill>
                <a:ln w="9525">
                  <a:solidFill>
                    <a:schemeClr val="accent3"/>
                  </a:solidFill>
                </a:ln>
                <a:effectLst/>
              </c:spPr>
            </c:marker>
            <c:bubble3D val="0"/>
            <c:spPr>
              <a:ln w="28575" cap="rnd">
                <a:solidFill>
                  <a:schemeClr val="tx1"/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7-1C79-4BED-A6B3-F4FF56ADD96C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Sayfa4!$C$3</c:f>
                <c:numCache>
                  <c:formatCode>General</c:formatCode>
                  <c:ptCount val="1"/>
                  <c:pt idx="0">
                    <c:v>8.8410630825472625E-2</c:v>
                  </c:pt>
                </c:numCache>
              </c:numRef>
            </c:plus>
            <c:minus>
              <c:numRef>
                <c:f>Sayfa4!$C$4</c:f>
                <c:numCache>
                  <c:formatCode>General</c:formatCode>
                  <c:ptCount val="1"/>
                  <c:pt idx="0">
                    <c:v>8.799015460060893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ayfa4!$E$1:$E$5</c:f>
              <c:strCache>
                <c:ptCount val="5"/>
                <c:pt idx="0">
                  <c:v>P-Baseline</c:v>
                </c:pt>
                <c:pt idx="1">
                  <c:v>P1</c:v>
                </c:pt>
                <c:pt idx="2">
                  <c:v>P2</c:v>
                </c:pt>
                <c:pt idx="3">
                  <c:v>P3</c:v>
                </c:pt>
                <c:pt idx="4">
                  <c:v>P4</c:v>
                </c:pt>
              </c:strCache>
            </c:strRef>
          </c:cat>
          <c:val>
            <c:numRef>
              <c:f>Sayfa4!$A$1:$A$5</c:f>
              <c:numCache>
                <c:formatCode>General</c:formatCode>
                <c:ptCount val="5"/>
                <c:pt idx="0">
                  <c:v>4.3380844494090907</c:v>
                </c:pt>
                <c:pt idx="1">
                  <c:v>4.2016717620151525</c:v>
                </c:pt>
                <c:pt idx="2">
                  <c:v>4.2097111213484864</c:v>
                </c:pt>
                <c:pt idx="3">
                  <c:v>4.2623936524242421</c:v>
                </c:pt>
                <c:pt idx="4">
                  <c:v>4.551662042606062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1C79-4BED-A6B3-F4FF56ADD96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886237456"/>
        <c:axId val="886234128"/>
      </c:lineChart>
      <c:catAx>
        <c:axId val="8862374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tr-TR"/>
          </a:p>
        </c:txPr>
        <c:crossAx val="886234128"/>
        <c:crosses val="autoZero"/>
        <c:auto val="1"/>
        <c:lblAlgn val="ctr"/>
        <c:lblOffset val="100"/>
        <c:noMultiLvlLbl val="0"/>
      </c:catAx>
      <c:valAx>
        <c:axId val="88623412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tr-TR"/>
                  <a:t>iCEB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tr-T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tr-TR"/>
          </a:p>
        </c:txPr>
        <c:crossAx val="8862374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rgbClr val="FFC000"/>
    </a:solidFill>
    <a:ln>
      <a:noFill/>
    </a:ln>
    <a:effectLst/>
  </c:spPr>
  <c:txPr>
    <a:bodyPr/>
    <a:lstStyle/>
    <a:p>
      <a:pPr>
        <a:defRPr/>
      </a:pPr>
      <a:endParaRPr lang="tr-TR"/>
    </a:p>
  </c:txPr>
  <c:externalData r:id="rId4">
    <c:autoUpdate val="0"/>
  </c:externalData>
  <c:userShapes r:id="rId5"/>
</c:chartSpace>
</file>

<file path=ppt/charts/colors1.xml><?xml version="1.0" encoding="utf-8"?>
<cs:colorStyle xmlns:cs="http://schemas.microsoft.com/office/drawing/2012/chartStyle" xmlns:a="http://schemas.openxmlformats.org/drawingml/2006/main" meth="withinLinear" id="16">
  <a:schemeClr val="accent3"/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1933</cdr:x>
      <cdr:y>0.5919</cdr:y>
    </cdr:from>
    <cdr:to>
      <cdr:x>0.85604</cdr:x>
      <cdr:y>0.67632</cdr:y>
    </cdr:to>
    <cdr:sp macro="" textlink="">
      <cdr:nvSpPr>
        <cdr:cNvPr id="2" name="Metin kutusu 1"/>
        <cdr:cNvSpPr txBox="1"/>
      </cdr:nvSpPr>
      <cdr:spPr>
        <a:xfrm xmlns:a="http://schemas.openxmlformats.org/drawingml/2006/main">
          <a:off x="812663" y="1428243"/>
          <a:ext cx="2359161" cy="20370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tr-TR" sz="1100" dirty="0" smtClean="0"/>
            <a:t>       *              *              *            *</a:t>
          </a:r>
          <a:endParaRPr lang="tr-TR" sz="1100" dirty="0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44C72DB-605E-0F4B-BEFA-F419CD777762}" type="datetimeFigureOut">
              <a:rPr lang="en-US" smtClean="0"/>
              <a:t>6/15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2032445-0623-A84C-A2C0-69350AC393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74099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ctr"/>
            <a:r>
              <a:rPr lang="en-US" dirty="0"/>
              <a:t>LU Biter, MMA Van </a:t>
            </a:r>
            <a:r>
              <a:rPr lang="en-US" dirty="0" err="1"/>
              <a:t>Buuren</a:t>
            </a:r>
            <a:r>
              <a:rPr lang="en-US" dirty="0"/>
              <a:t>, GHH </a:t>
            </a:r>
            <a:r>
              <a:rPr lang="en-US" dirty="0" err="1"/>
              <a:t>Mannaerts</a:t>
            </a:r>
            <a:endParaRPr lang="en-US" dirty="0"/>
          </a:p>
          <a:p>
            <a:pPr algn="ctr"/>
            <a:r>
              <a:rPr lang="en-US" dirty="0"/>
              <a:t>JA </a:t>
            </a:r>
            <a:r>
              <a:rPr lang="en-US" dirty="0" err="1"/>
              <a:t>Apers</a:t>
            </a:r>
            <a:r>
              <a:rPr lang="en-US" dirty="0"/>
              <a:t>, M </a:t>
            </a:r>
            <a:r>
              <a:rPr lang="en-US" dirty="0" err="1"/>
              <a:t>Dunkelgrun</a:t>
            </a:r>
            <a:r>
              <a:rPr lang="en-US" dirty="0"/>
              <a:t>, GHEJ </a:t>
            </a:r>
            <a:r>
              <a:rPr lang="en-US" dirty="0" err="1"/>
              <a:t>Vikgen</a:t>
            </a:r>
            <a:r>
              <a:rPr lang="en-US" dirty="0"/>
              <a:t>, </a:t>
            </a:r>
            <a:r>
              <a:rPr lang="en-US" i="1" dirty="0"/>
              <a:t>May 2017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2032445-0623-A84C-A2C0-69350AC3936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38454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C3EE756-DF6A-4713-89FB-98A46E28C75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2C860C0B-2E9F-49F2-9460-46107BB63EE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6825DCB-86FC-4DA3-AAA0-627B9BBD9C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15/06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5987355-6512-4423-AC1B-44E24981C9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1233452-DDA1-4B3F-9C13-132C5DEA44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529516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C7F0807-81D0-4253-B234-B374B0C606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DC57DABB-378F-4D89-A706-F66973DD9C9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9442D99-3C3A-4B78-BE35-4A3FB9255B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15/06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E0E2A6A-BA6C-49EA-8ACD-3324BB1117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4BB33F4-9B5D-430C-B6B8-2BF170C4B6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131889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4087BF07-E783-4E4B-8E99-782AE0353A4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F20F25FB-97CC-44E1-A9BF-2361087D878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C3D29A0-66AF-4AC9-BDD4-CCEC785375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15/06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1B806D9-654B-4B39-ACBB-2178013F60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A6EF732-C326-4E32-BE60-3B42041F77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683026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0DCD913-2CE9-47F7-8DF5-B55ADD1012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700A6B60-4094-4F4D-BD34-EE380470B0D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5FD9612-5AA2-4662-A788-6D5E9D8366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15/06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53694D7-CE1C-425E-97DC-4AF93B8239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25BF268-142F-4DBE-BB43-8764EE7CDF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421475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7F7D608-CC5D-4254-A13D-6149D786B6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163DE456-BABE-4339-B81C-0221CB9A73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56B46DD-355D-47F9-89D6-3C8FD871FE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15/06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932A418-F68D-40C2-B56B-EC7B0CC85E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6304BAF-57B9-4258-97AA-43E4FA100B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01155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EDB117F-BC84-42A5-80C3-4D888B6091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B3478E9A-D498-424D-9EE8-2B0E59BD946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C19E52A5-B8D8-487B-B656-EFCE9EB0A80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FCFA8D9E-F1A2-4B9C-9A32-A9D0783E50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15/06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5982C0B3-010E-4F67-BAC5-B6226BEB79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A754FCA9-6502-43C3-9124-9FD237787F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436710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4E98D27-7505-46CB-B8CA-7760BED6AD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420B258A-83CD-4E3A-A4DC-155F400B05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0BE29E82-81E4-447F-9030-CF239E877C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1954D1AA-0AC7-4212-8332-5D5D359139E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95ABE488-E097-45CF-A269-E06BBEE5AB6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D77A92D5-E2FC-4B8D-B28A-733544C12D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15/06/2025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2B4839BF-D838-4C3D-9567-9797435B85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1C683122-6F71-40F3-9FE4-0E271C1DD7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086016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FDB1BDF-B62F-4DD8-8A1C-0071710360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8867A061-5397-43AE-857F-8483161786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15/06/2025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79BDDE2E-0059-4B34-A48B-D3C8D242CD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50DB4436-B0AA-4133-9FCF-32D245D991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756902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BA02C732-CCD5-4ADA-B6AD-A92323F50E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15/06/2025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DD31A62A-4978-4089-8105-BDD96727DB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9F505B86-1899-4229-8FCF-4930257019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16544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5822F80-6FCE-432B-B81C-621EE802AE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C738CBAF-9ED8-473F-9938-BC785CD39DC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3D2B786E-0C7B-4C02-9BF9-F64BB8017B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5CC700F8-1C90-435C-8F29-C932B7D1EB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15/06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194CDB35-1EDE-41BA-9492-286F1368D1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D60AF755-D296-4197-8C45-EDF1CDA937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459332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A7F0283-8A56-4501-A1BC-4CFA1C9717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B41ADA50-9ECC-4627-8967-B457905C1E7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80699504-8609-4515-AC65-4B9187F9A26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A1EFFA4E-9FAB-4AB5-96AA-8E05FB8C92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15/06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61919DB2-E3CE-4DB6-8C6E-6DD387ABEE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0D2811A8-F934-493D-8B84-59CE2D22CF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237376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108BE410-AACE-489A-830B-919842636C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2A74C952-12DB-44E4-8E5F-CD7FAB1C85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3FEA6A1-94CC-4E43-9EB0-CB7BA1DD83D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4ACE20-333B-44FF-8048-BDE66E2D3417}" type="datetimeFigureOut">
              <a:rPr lang="it-IT" smtClean="0"/>
              <a:t>15/06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63ACA87-6133-4DF5-A554-934070FFF8A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A6DE944-0076-43EB-8EE2-25BA726A93F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890082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E806FAF-9D3E-49D9-BF3D-E9CCC82B410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it-IT" dirty="0"/>
          </a:p>
          <a:p>
            <a:endParaRPr lang="it-IT" dirty="0"/>
          </a:p>
        </p:txBody>
      </p:sp>
      <p:sp>
        <p:nvSpPr>
          <p:cNvPr id="4" name="Rettangolo 3">
            <a:extLst>
              <a:ext uri="{FF2B5EF4-FFF2-40B4-BE49-F238E27FC236}">
                <a16:creationId xmlns:a16="http://schemas.microsoft.com/office/drawing/2014/main" id="{5C047ED4-52E3-4A2A-948B-20CE7D7233A4}"/>
              </a:ext>
            </a:extLst>
          </p:cNvPr>
          <p:cNvSpPr/>
          <p:nvPr/>
        </p:nvSpPr>
        <p:spPr>
          <a:xfrm>
            <a:off x="10161" y="767461"/>
            <a:ext cx="12192000" cy="4805131"/>
          </a:xfrm>
          <a:prstGeom prst="rect">
            <a:avLst/>
          </a:prstGeom>
          <a:solidFill>
            <a:srgbClr val="99B2D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b="1" dirty="0" smtClean="0"/>
              <a:t>P1 (Anesthesia induction+Supine)</a:t>
            </a:r>
            <a:endParaRPr lang="it-IT" dirty="0"/>
          </a:p>
        </p:txBody>
      </p:sp>
      <p:sp>
        <p:nvSpPr>
          <p:cNvPr id="5" name="Rettangolo 4">
            <a:extLst>
              <a:ext uri="{FF2B5EF4-FFF2-40B4-BE49-F238E27FC236}">
                <a16:creationId xmlns:a16="http://schemas.microsoft.com/office/drawing/2014/main" id="{57C6657B-C862-4624-AF23-0815F276EF35}"/>
              </a:ext>
            </a:extLst>
          </p:cNvPr>
          <p:cNvSpPr/>
          <p:nvPr/>
        </p:nvSpPr>
        <p:spPr>
          <a:xfrm>
            <a:off x="4044781" y="774991"/>
            <a:ext cx="4183678" cy="4805131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pic>
        <p:nvPicPr>
          <p:cNvPr id="7" name="Immagine 6">
            <a:extLst>
              <a:ext uri="{FF2B5EF4-FFF2-40B4-BE49-F238E27FC236}">
                <a16:creationId xmlns:a16="http://schemas.microsoft.com/office/drawing/2014/main" id="{9D7F0B6B-053D-4EF4-A94B-964FCCCABAE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648570" y="5788510"/>
            <a:ext cx="3425124" cy="714488"/>
          </a:xfrm>
          <a:prstGeom prst="rect">
            <a:avLst/>
          </a:prstGeom>
        </p:spPr>
      </p:pic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40F199E0-EF0A-4852-8CD5-FCA17ED84623}"/>
              </a:ext>
            </a:extLst>
          </p:cNvPr>
          <p:cNvSpPr txBox="1"/>
          <p:nvPr/>
        </p:nvSpPr>
        <p:spPr>
          <a:xfrm>
            <a:off x="430476" y="970492"/>
            <a:ext cx="302768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2800" b="1" dirty="0"/>
              <a:t>    METHOD</a:t>
            </a:r>
            <a:r>
              <a:rPr lang="it-IT" b="1" dirty="0"/>
              <a:t>	</a:t>
            </a: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F89B844B-5329-4EF8-A25F-1F177F64B210}"/>
              </a:ext>
            </a:extLst>
          </p:cNvPr>
          <p:cNvSpPr txBox="1"/>
          <p:nvPr/>
        </p:nvSpPr>
        <p:spPr>
          <a:xfrm>
            <a:off x="4346457" y="1064381"/>
            <a:ext cx="305816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2800" b="1" dirty="0"/>
              <a:t>RESULTS</a:t>
            </a:r>
          </a:p>
        </p:txBody>
      </p:sp>
      <p:pic>
        <p:nvPicPr>
          <p:cNvPr id="6" name="Immagine 5">
            <a:extLst>
              <a:ext uri="{FF2B5EF4-FFF2-40B4-BE49-F238E27FC236}">
                <a16:creationId xmlns:a16="http://schemas.microsoft.com/office/drawing/2014/main" id="{E2FD73DB-5170-483D-8AED-73807F7EFBAA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682"/>
          <a:stretch/>
        </p:blipFill>
        <p:spPr>
          <a:xfrm>
            <a:off x="0" y="5589917"/>
            <a:ext cx="2592354" cy="1268084"/>
          </a:xfrm>
          <a:prstGeom prst="rect">
            <a:avLst/>
          </a:prstGeom>
        </p:spPr>
      </p:pic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7E841DD3-FD98-4EB0-9BD3-D2A17CABA7C9}"/>
              </a:ext>
            </a:extLst>
          </p:cNvPr>
          <p:cNvSpPr txBox="1"/>
          <p:nvPr/>
        </p:nvSpPr>
        <p:spPr>
          <a:xfrm>
            <a:off x="10161" y="72508"/>
            <a:ext cx="12181840" cy="6704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tr-TR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</a:t>
            </a:r>
            <a:r>
              <a:rPr lang="tr-TR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mpact</a:t>
            </a:r>
            <a:r>
              <a:rPr lang="tr-TR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f </a:t>
            </a:r>
            <a:r>
              <a:rPr lang="tr-TR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traoperative</a:t>
            </a:r>
            <a:r>
              <a:rPr lang="tr-TR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osition</a:t>
            </a:r>
            <a:r>
              <a:rPr lang="tr-TR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hanges</a:t>
            </a:r>
            <a:r>
              <a:rPr lang="tr-TR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n </a:t>
            </a:r>
            <a:r>
              <a:rPr lang="tr-TR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emodynamics</a:t>
            </a:r>
            <a:r>
              <a:rPr lang="tr-TR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</a:t>
            </a:r>
            <a:r>
              <a:rPr lang="tr-TR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ardiac </a:t>
            </a:r>
            <a:r>
              <a:rPr lang="tr-TR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lectrophysiological</a:t>
            </a:r>
            <a:r>
              <a:rPr lang="tr-TR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alance</a:t>
            </a:r>
            <a:r>
              <a:rPr lang="tr-TR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dex in </a:t>
            </a:r>
            <a:r>
              <a:rPr lang="tr-TR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atients</a:t>
            </a:r>
            <a:r>
              <a:rPr lang="tr-TR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ith</a:t>
            </a:r>
            <a:r>
              <a:rPr lang="tr-TR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evere </a:t>
            </a:r>
            <a:r>
              <a:rPr lang="tr-TR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besity</a:t>
            </a:r>
            <a:r>
              <a:rPr lang="tr-TR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ndergoing</a:t>
            </a:r>
            <a:r>
              <a:rPr lang="tr-TR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aparoscopic</a:t>
            </a:r>
            <a:r>
              <a:rPr lang="tr-TR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leeve</a:t>
            </a:r>
            <a:r>
              <a:rPr lang="tr-TR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astrectomy</a:t>
            </a:r>
            <a:endParaRPr lang="tr-TR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27" name="Rectangle 126"/>
          <p:cNvSpPr/>
          <p:nvPr/>
        </p:nvSpPr>
        <p:spPr>
          <a:xfrm>
            <a:off x="9076820" y="1064381"/>
            <a:ext cx="2175170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it-IT" sz="2800" b="1" dirty="0"/>
              <a:t>CONCLUSION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003F1B40-FED4-94F2-5A90-654A90DDD565}"/>
              </a:ext>
            </a:extLst>
          </p:cNvPr>
          <p:cNvSpPr/>
          <p:nvPr/>
        </p:nvSpPr>
        <p:spPr>
          <a:xfrm>
            <a:off x="2702935" y="5777553"/>
            <a:ext cx="5653413" cy="714487"/>
          </a:xfrm>
          <a:prstGeom prst="rect">
            <a:avLst/>
          </a:prstGeom>
          <a:noFill/>
          <a:ln w="28575">
            <a:solidFill>
              <a:srgbClr val="010C9D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97BA675-CE27-87DF-03FC-E1C2B287BDD8}"/>
              </a:ext>
            </a:extLst>
          </p:cNvPr>
          <p:cNvSpPr txBox="1"/>
          <p:nvPr/>
        </p:nvSpPr>
        <p:spPr>
          <a:xfrm>
            <a:off x="3823198" y="6192024"/>
            <a:ext cx="34128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(Please keep this space clear for review purposes)</a:t>
            </a:r>
          </a:p>
        </p:txBody>
      </p:sp>
      <p:sp>
        <p:nvSpPr>
          <p:cNvPr id="15" name="Alt Başlık 2"/>
          <p:cNvSpPr txBox="1">
            <a:spLocks/>
          </p:cNvSpPr>
          <p:nvPr/>
        </p:nvSpPr>
        <p:spPr>
          <a:xfrm>
            <a:off x="709596" y="1527902"/>
            <a:ext cx="3263005" cy="474939"/>
          </a:xfrm>
          <a:prstGeom prst="rect">
            <a:avLst/>
          </a:prstGeom>
          <a:solidFill>
            <a:schemeClr val="bg2"/>
          </a:solidFill>
        </p:spPr>
        <p:txBody>
          <a:bodyPr vert="horz" lIns="91440" tIns="45720" rIns="91440" bIns="45720" rtlCol="0">
            <a:no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0" lang="en-US" sz="1100" b="0" i="0" u="none" strike="noStrike" kern="120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atients undergoing laparoscopic sleeve</a:t>
            </a:r>
            <a:r>
              <a:rPr kumimoji="0" lang="tr-TR" sz="1100" b="0" i="0" u="none" strike="noStrike" kern="1200" cap="none" spc="0" normalizeH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en-US" sz="1100" b="0" i="0" u="none" strike="noStrike" kern="120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gastrectomy (Mean BMI 45.38±5.78 kg/m2, n=66) </a:t>
            </a:r>
            <a:endParaRPr kumimoji="0" lang="tr-TR" sz="1100" b="0" i="0" u="none" strike="noStrike" kern="1200" cap="none" spc="0" normalizeH="0" baseline="0" noProof="0" dirty="0" smtClean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13" name="Resim 12"/>
          <p:cNvPicPr>
            <a:picLocks noChangeAspect="1"/>
          </p:cNvPicPr>
          <p:nvPr/>
        </p:nvPicPr>
        <p:blipFill rotWithShape="1">
          <a:blip r:embed="rId5"/>
          <a:srcRect l="2591" t="2713" r="3044"/>
          <a:stretch/>
        </p:blipFill>
        <p:spPr>
          <a:xfrm>
            <a:off x="2341098" y="4708058"/>
            <a:ext cx="559710" cy="517909"/>
          </a:xfrm>
          <a:prstGeom prst="rect">
            <a:avLst/>
          </a:prstGeom>
        </p:spPr>
      </p:pic>
      <p:pic>
        <p:nvPicPr>
          <p:cNvPr id="16" name="Resim 1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012031" y="4704187"/>
            <a:ext cx="500628" cy="511152"/>
          </a:xfrm>
          <a:prstGeom prst="rect">
            <a:avLst/>
          </a:prstGeom>
        </p:spPr>
      </p:pic>
      <p:sp>
        <p:nvSpPr>
          <p:cNvPr id="28" name="İçerik Yer Tutucusu 2"/>
          <p:cNvSpPr txBox="1">
            <a:spLocks/>
          </p:cNvSpPr>
          <p:nvPr/>
        </p:nvSpPr>
        <p:spPr>
          <a:xfrm>
            <a:off x="126830" y="2198703"/>
            <a:ext cx="891945" cy="325095"/>
          </a:xfrm>
          <a:prstGeom prst="rect">
            <a:avLst/>
          </a:prstGeom>
          <a:solidFill>
            <a:schemeClr val="bg1"/>
          </a:solidFill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tr-TR" sz="1000" dirty="0" smtClean="0">
                <a:ea typeface="Calibri" panose="020F0502020204030204" pitchFamily="34" charset="0"/>
              </a:rPr>
              <a:t>P-</a:t>
            </a:r>
            <a:r>
              <a:rPr lang="tr-TR" sz="1000" dirty="0" err="1">
                <a:ea typeface="Calibri" panose="020F0502020204030204" pitchFamily="34" charset="0"/>
              </a:rPr>
              <a:t>B</a:t>
            </a:r>
            <a:r>
              <a:rPr lang="tr-TR" sz="1000" dirty="0" err="1" smtClean="0">
                <a:ea typeface="Calibri" panose="020F0502020204030204" pitchFamily="34" charset="0"/>
              </a:rPr>
              <a:t>aseline</a:t>
            </a:r>
            <a:endParaRPr lang="tr-TR" sz="1000" dirty="0"/>
          </a:p>
        </p:txBody>
      </p:sp>
      <p:sp>
        <p:nvSpPr>
          <p:cNvPr id="34" name="İçerik Yer Tutucusu 2"/>
          <p:cNvSpPr txBox="1">
            <a:spLocks/>
          </p:cNvSpPr>
          <p:nvPr/>
        </p:nvSpPr>
        <p:spPr>
          <a:xfrm>
            <a:off x="8720840" y="2593436"/>
            <a:ext cx="1359705" cy="27554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endParaRPr kumimoji="0" lang="tr-TR" sz="800" b="0" i="0" u="none" strike="noStrike" kern="1200" cap="none" spc="0" normalizeH="0" baseline="0" noProof="0" dirty="0" smtClean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33" name="Resim 3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26830" y="1319076"/>
            <a:ext cx="202894" cy="315761"/>
          </a:xfrm>
          <a:prstGeom prst="rect">
            <a:avLst/>
          </a:prstGeom>
        </p:spPr>
      </p:pic>
      <p:pic>
        <p:nvPicPr>
          <p:cNvPr id="35" name="Resim 34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04455" y="1315535"/>
            <a:ext cx="204552" cy="319302"/>
          </a:xfrm>
          <a:prstGeom prst="rect">
            <a:avLst/>
          </a:prstGeom>
        </p:spPr>
      </p:pic>
      <p:pic>
        <p:nvPicPr>
          <p:cNvPr id="36" name="Resim 35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96876" y="1712846"/>
            <a:ext cx="201887" cy="315141"/>
          </a:xfrm>
          <a:prstGeom prst="rect">
            <a:avLst/>
          </a:prstGeom>
        </p:spPr>
      </p:pic>
      <p:sp>
        <p:nvSpPr>
          <p:cNvPr id="41" name="İçerik Yer Tutucusu 3"/>
          <p:cNvSpPr txBox="1">
            <a:spLocks/>
          </p:cNvSpPr>
          <p:nvPr/>
        </p:nvSpPr>
        <p:spPr>
          <a:xfrm>
            <a:off x="2437435" y="2396297"/>
            <a:ext cx="1507836" cy="197139"/>
          </a:xfrm>
          <a:prstGeom prst="rect">
            <a:avLst/>
          </a:prstGeom>
        </p:spPr>
        <p:txBody>
          <a:bodyPr vert="horz" lIns="91440" tIns="45720" rIns="91440" bIns="45720" rtlCol="0">
            <a:normAutofit lnSpcReduction="1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endParaRPr lang="tr-TR" sz="800" dirty="0" smtClean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40" name="Resim 39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815709" y="2705907"/>
            <a:ext cx="968023" cy="617886"/>
          </a:xfrm>
          <a:prstGeom prst="rect">
            <a:avLst/>
          </a:prstGeom>
        </p:spPr>
      </p:pic>
      <p:pic>
        <p:nvPicPr>
          <p:cNvPr id="46" name="Resim 45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182746" y="4084097"/>
            <a:ext cx="878470" cy="594047"/>
          </a:xfrm>
          <a:prstGeom prst="rect">
            <a:avLst/>
          </a:prstGeom>
        </p:spPr>
      </p:pic>
      <p:pic>
        <p:nvPicPr>
          <p:cNvPr id="49" name="Resim 48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29080" y="4063706"/>
            <a:ext cx="882052" cy="595478"/>
          </a:xfrm>
          <a:prstGeom prst="rect">
            <a:avLst/>
          </a:prstGeom>
        </p:spPr>
      </p:pic>
      <p:pic>
        <p:nvPicPr>
          <p:cNvPr id="53" name="Resim 52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31412" y="2727995"/>
            <a:ext cx="790811" cy="604331"/>
          </a:xfrm>
          <a:prstGeom prst="rect">
            <a:avLst/>
          </a:prstGeom>
        </p:spPr>
      </p:pic>
      <p:pic>
        <p:nvPicPr>
          <p:cNvPr id="54" name="Resim 53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463280" y="2707926"/>
            <a:ext cx="818885" cy="624400"/>
          </a:xfrm>
          <a:prstGeom prst="rect">
            <a:avLst/>
          </a:prstGeom>
        </p:spPr>
      </p:pic>
      <p:sp>
        <p:nvSpPr>
          <p:cNvPr id="57" name="İçerik Yer Tutucusu 2"/>
          <p:cNvSpPr txBox="1">
            <a:spLocks/>
          </p:cNvSpPr>
          <p:nvPr/>
        </p:nvSpPr>
        <p:spPr>
          <a:xfrm>
            <a:off x="412679" y="5274840"/>
            <a:ext cx="3069430" cy="238578"/>
          </a:xfrm>
          <a:prstGeom prst="rect">
            <a:avLst/>
          </a:prstGeom>
          <a:solidFill>
            <a:schemeClr val="bg2"/>
          </a:solidFill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0" lang="en-US" sz="1100" b="0" i="0" u="none" strike="noStrike" kern="120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tudy period: From February 2025 to May 2025</a:t>
            </a:r>
            <a:endParaRPr kumimoji="0" lang="tr-TR" sz="1100" b="0" i="0" u="none" strike="noStrike" kern="1200" cap="none" spc="0" normalizeH="0" baseline="0" noProof="0" dirty="0" smtClean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9" name="Sağ Ok 8"/>
          <p:cNvSpPr/>
          <p:nvPr/>
        </p:nvSpPr>
        <p:spPr>
          <a:xfrm>
            <a:off x="1033080" y="2957469"/>
            <a:ext cx="324219" cy="14474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tr-TR"/>
          </a:p>
        </p:txBody>
      </p:sp>
      <p:sp>
        <p:nvSpPr>
          <p:cNvPr id="10" name="Sağ Ok 9"/>
          <p:cNvSpPr/>
          <p:nvPr/>
        </p:nvSpPr>
        <p:spPr>
          <a:xfrm>
            <a:off x="2400615" y="2934362"/>
            <a:ext cx="325591" cy="16038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tr-TR"/>
          </a:p>
        </p:txBody>
      </p:sp>
      <p:sp>
        <p:nvSpPr>
          <p:cNvPr id="37" name="Sağ Ok 36"/>
          <p:cNvSpPr/>
          <p:nvPr/>
        </p:nvSpPr>
        <p:spPr>
          <a:xfrm>
            <a:off x="1533177" y="4303509"/>
            <a:ext cx="352297" cy="14603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tr-TR"/>
          </a:p>
        </p:txBody>
      </p:sp>
      <p:sp>
        <p:nvSpPr>
          <p:cNvPr id="38" name="Alt Başlık 2"/>
          <p:cNvSpPr txBox="1">
            <a:spLocks/>
          </p:cNvSpPr>
          <p:nvPr/>
        </p:nvSpPr>
        <p:spPr>
          <a:xfrm>
            <a:off x="1258640" y="2141614"/>
            <a:ext cx="1283243" cy="466684"/>
          </a:xfrm>
          <a:prstGeom prst="rect">
            <a:avLst/>
          </a:prstGeom>
          <a:solidFill>
            <a:schemeClr val="bg1"/>
          </a:solidFill>
        </p:spPr>
        <p:txBody>
          <a:bodyPr vert="horz" lIns="91440" tIns="45720" rIns="91440" bIns="45720" rtlCol="0">
            <a:no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0" lang="tr-TR" sz="1000" b="0" i="0" u="none" strike="noStrike" kern="120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P1 (</a:t>
            </a:r>
            <a:r>
              <a:rPr kumimoji="0" lang="tr-TR" sz="1000" b="0" i="0" u="none" strike="noStrike" kern="1200" cap="none" spc="0" normalizeH="0" baseline="0" noProof="0" dirty="0" err="1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cs typeface="Calibri" panose="020F0502020204030204" pitchFamily="34" charset="0"/>
              </a:rPr>
              <a:t>Anesthesia</a:t>
            </a:r>
            <a:r>
              <a:rPr kumimoji="0" lang="tr-TR" sz="1000" b="0" i="0" u="none" strike="noStrike" kern="120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 </a:t>
            </a:r>
            <a:r>
              <a:rPr kumimoji="0" lang="tr-TR" sz="1000" b="0" i="0" u="none" strike="noStrike" kern="1200" cap="none" spc="0" normalizeH="0" baseline="0" noProof="0" dirty="0" err="1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induction</a:t>
            </a:r>
            <a:r>
              <a:rPr kumimoji="0" lang="tr-TR" sz="1000" b="0" i="0" u="none" strike="noStrike" kern="120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 + </a:t>
            </a:r>
            <a:r>
              <a:rPr kumimoji="0" lang="tr-TR" sz="1000" b="0" i="0" u="none" strike="noStrike" kern="1200" cap="none" spc="0" normalizeH="0" baseline="0" noProof="0" dirty="0" err="1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Supine</a:t>
            </a:r>
            <a:r>
              <a:rPr kumimoji="0" lang="tr-TR" sz="1000" b="0" i="0" u="none" strike="noStrike" kern="120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)</a:t>
            </a:r>
          </a:p>
        </p:txBody>
      </p:sp>
      <p:sp>
        <p:nvSpPr>
          <p:cNvPr id="39" name="Alt Başlık 4"/>
          <p:cNvSpPr txBox="1">
            <a:spLocks/>
          </p:cNvSpPr>
          <p:nvPr/>
        </p:nvSpPr>
        <p:spPr>
          <a:xfrm>
            <a:off x="2621981" y="2130191"/>
            <a:ext cx="1348719" cy="464561"/>
          </a:xfrm>
          <a:prstGeom prst="rect">
            <a:avLst/>
          </a:prstGeom>
          <a:solidFill>
            <a:schemeClr val="bg1"/>
          </a:solidFill>
        </p:spPr>
        <p:txBody>
          <a:bodyPr vert="horz" lIns="91440" tIns="45720" rIns="91440" bIns="45720" rtlCol="0">
            <a:normAutofit lnSpcReduction="10000"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0" lang="tr-TR" sz="1000" b="0" i="0" u="none" strike="noStrike" kern="120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2 (</a:t>
            </a:r>
            <a:r>
              <a:rPr kumimoji="0" lang="tr-TR" sz="1000" b="0" i="0" u="none" strike="noStrike" kern="1200" cap="none" spc="0" normalizeH="0" baseline="0" noProof="0" dirty="0" err="1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neumoperitoneum</a:t>
            </a:r>
            <a:r>
              <a:rPr kumimoji="0" lang="tr-TR" sz="1000" b="0" i="0" u="none" strike="noStrike" kern="120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+ </a:t>
            </a:r>
            <a:r>
              <a:rPr kumimoji="0" lang="tr-TR" sz="1000" b="0" i="0" u="none" strike="noStrike" kern="1200" cap="none" spc="0" normalizeH="0" baseline="0" noProof="0" dirty="0" err="1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pine</a:t>
            </a:r>
            <a:r>
              <a:rPr kumimoji="0" lang="tr-TR" sz="1000" b="0" i="0" u="none" strike="noStrike" kern="120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)</a:t>
            </a:r>
          </a:p>
        </p:txBody>
      </p:sp>
      <p:sp>
        <p:nvSpPr>
          <p:cNvPr id="42" name="İçerik Yer Tutucusu 2"/>
          <p:cNvSpPr txBox="1">
            <a:spLocks/>
          </p:cNvSpPr>
          <p:nvPr/>
        </p:nvSpPr>
        <p:spPr>
          <a:xfrm>
            <a:off x="64422" y="3571598"/>
            <a:ext cx="1589471" cy="416882"/>
          </a:xfrm>
          <a:prstGeom prst="rect">
            <a:avLst/>
          </a:prstGeom>
          <a:solidFill>
            <a:schemeClr val="bg1"/>
          </a:solidFill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0" lang="tr-TR" sz="1000" b="0" i="0" u="none" strike="noStrike" kern="120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3 (</a:t>
            </a:r>
            <a:r>
              <a:rPr kumimoji="0" lang="tr-TR" sz="1000" b="0" i="0" u="none" strike="noStrike" kern="1200" cap="none" spc="0" normalizeH="0" baseline="0" noProof="0" dirty="0" err="1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neumoperitoneum</a:t>
            </a:r>
            <a:r>
              <a:rPr kumimoji="0" lang="tr-TR" sz="1000" b="0" i="0" u="none" strike="noStrike" kern="120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+ </a:t>
            </a:r>
            <a:r>
              <a:rPr kumimoji="0" lang="tr-TR" sz="1000" b="0" i="0" u="none" strike="noStrike" kern="1200" cap="none" spc="0" normalizeH="0" baseline="0" noProof="0" dirty="0" err="1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Reverse</a:t>
            </a:r>
            <a:r>
              <a:rPr lang="tr-TR" sz="1000" dirty="0">
                <a:solidFill>
                  <a:sysClr val="windowText" lastClr="000000"/>
                </a:solidFill>
                <a:latin typeface="Calibri" panose="020F0502020204030204"/>
              </a:rPr>
              <a:t> </a:t>
            </a:r>
            <a:r>
              <a:rPr kumimoji="0" lang="tr-TR" sz="1000" b="0" i="0" u="none" strike="noStrike" kern="1200" cap="none" spc="0" normalizeH="0" baseline="0" noProof="0" dirty="0" err="1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Trendelenburg</a:t>
            </a:r>
            <a:r>
              <a:rPr kumimoji="0" lang="tr-TR" sz="1000" b="0" i="0" u="none" strike="noStrike" kern="120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)</a:t>
            </a:r>
          </a:p>
        </p:txBody>
      </p:sp>
      <p:sp>
        <p:nvSpPr>
          <p:cNvPr id="43" name="İçerik Yer Tutucusu 2"/>
          <p:cNvSpPr txBox="1">
            <a:spLocks/>
          </p:cNvSpPr>
          <p:nvPr/>
        </p:nvSpPr>
        <p:spPr>
          <a:xfrm>
            <a:off x="1708154" y="3570595"/>
            <a:ext cx="1488064" cy="411021"/>
          </a:xfrm>
          <a:prstGeom prst="rect">
            <a:avLst/>
          </a:prstGeom>
          <a:solidFill>
            <a:schemeClr val="bg1"/>
          </a:solidFill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tr-TR" sz="1000" dirty="0" smtClean="0"/>
              <a:t>P4 (</a:t>
            </a:r>
            <a:r>
              <a:rPr lang="tr-TR" sz="1000" dirty="0" err="1" smtClean="0"/>
              <a:t>Pneumoperitoneum</a:t>
            </a:r>
            <a:r>
              <a:rPr lang="tr-TR" sz="1000" dirty="0" smtClean="0"/>
              <a:t> </a:t>
            </a:r>
            <a:r>
              <a:rPr lang="tr-TR" sz="1000" dirty="0" err="1" smtClean="0"/>
              <a:t>desufflation</a:t>
            </a:r>
            <a:r>
              <a:rPr lang="tr-TR" sz="1000" dirty="0" smtClean="0"/>
              <a:t> + </a:t>
            </a:r>
            <a:r>
              <a:rPr lang="tr-TR" sz="1000" dirty="0" err="1" smtClean="0"/>
              <a:t>Reverse</a:t>
            </a:r>
            <a:r>
              <a:rPr lang="tr-TR" sz="1000" dirty="0" smtClean="0"/>
              <a:t> </a:t>
            </a:r>
            <a:r>
              <a:rPr lang="tr-TR" sz="1000" dirty="0" err="1" smtClean="0"/>
              <a:t>Trendelenburg</a:t>
            </a:r>
            <a:r>
              <a:rPr lang="tr-TR" sz="1000" dirty="0" smtClean="0"/>
              <a:t>)</a:t>
            </a:r>
          </a:p>
        </p:txBody>
      </p:sp>
      <p:sp>
        <p:nvSpPr>
          <p:cNvPr id="24" name="Sola Bükülü Ok 23"/>
          <p:cNvSpPr/>
          <p:nvPr/>
        </p:nvSpPr>
        <p:spPr>
          <a:xfrm>
            <a:off x="3595771" y="3434947"/>
            <a:ext cx="392317" cy="1661568"/>
          </a:xfrm>
          <a:prstGeom prst="curvedLeftArrow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tr-TR">
              <a:solidFill>
                <a:schemeClr val="tx1"/>
              </a:solidFill>
            </a:endParaRPr>
          </a:p>
        </p:txBody>
      </p:sp>
      <p:sp>
        <p:nvSpPr>
          <p:cNvPr id="44" name="Alt Başlık 2"/>
          <p:cNvSpPr txBox="1">
            <a:spLocks/>
          </p:cNvSpPr>
          <p:nvPr/>
        </p:nvSpPr>
        <p:spPr>
          <a:xfrm>
            <a:off x="1517009" y="4831258"/>
            <a:ext cx="809979" cy="404524"/>
          </a:xfrm>
          <a:prstGeom prst="rect">
            <a:avLst/>
          </a:prstGeom>
          <a:solidFill>
            <a:schemeClr val="accent4"/>
          </a:solidFill>
        </p:spPr>
        <p:txBody>
          <a:bodyPr vert="horz" lIns="91440" tIns="45720" rIns="91440" bIns="45720" rtlCol="0">
            <a:norm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ctr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0" lang="tr-TR" sz="1000" b="0" i="0" u="none" strike="noStrike" kern="1200" cap="none" spc="0" normalizeH="0" baseline="0" noProof="0" dirty="0" err="1" smtClean="0">
                <a:ln>
                  <a:noFill/>
                </a:ln>
                <a:solidFill>
                  <a:srgbClr val="1B1B1B"/>
                </a:solidFill>
                <a:effectLst/>
                <a:uLnTx/>
                <a:uFillTx/>
                <a:latin typeface="Calibri" panose="020F0502020204030204"/>
                <a:ea typeface="Calibri" panose="020F0502020204030204" pitchFamily="34" charset="0"/>
                <a:cs typeface="+mn-cs"/>
              </a:rPr>
              <a:t>iCEB</a:t>
            </a:r>
            <a:r>
              <a:rPr kumimoji="0" lang="tr-TR" sz="1000" b="0" i="0" u="none" strike="noStrike" kern="1200" cap="none" spc="0" normalizeH="0" baseline="0" noProof="0" dirty="0" smtClean="0">
                <a:ln>
                  <a:noFill/>
                </a:ln>
                <a:solidFill>
                  <a:srgbClr val="1B1B1B"/>
                </a:solidFill>
                <a:effectLst/>
                <a:uLnTx/>
                <a:uFillTx/>
                <a:latin typeface="Calibri" panose="020F0502020204030204"/>
                <a:ea typeface="Calibri" panose="020F0502020204030204" pitchFamily="34" charset="0"/>
                <a:cs typeface="+mn-cs"/>
              </a:rPr>
              <a:t> (QT/QRS)</a:t>
            </a:r>
            <a:endParaRPr kumimoji="0" lang="tr-TR" sz="1000" b="0" i="0" u="none" strike="noStrike" kern="1200" cap="none" spc="0" normalizeH="0" baseline="0" noProof="0" dirty="0" smtClean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  <a:latin typeface="Calibri" panose="020F0502020204030204"/>
              <a:cs typeface="+mn-cs"/>
            </a:endParaRPr>
          </a:p>
        </p:txBody>
      </p:sp>
      <p:sp>
        <p:nvSpPr>
          <p:cNvPr id="45" name="İçerik Yer Tutucusu 2"/>
          <p:cNvSpPr txBox="1">
            <a:spLocks/>
          </p:cNvSpPr>
          <p:nvPr/>
        </p:nvSpPr>
        <p:spPr>
          <a:xfrm>
            <a:off x="8374429" y="1712846"/>
            <a:ext cx="3565996" cy="3644245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</p:spPr>
        <p:txBody>
          <a:bodyPr vert="horz" lIns="91440" tIns="45720" rIns="91440" bIns="45720" rtlCol="0">
            <a:normAutofit lnSpcReduction="1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342900" lvl="0" indent="-342900" algn="just">
              <a:lnSpc>
                <a:spcPct val="200000"/>
              </a:lnSpc>
              <a:spcAft>
                <a:spcPts val="800"/>
              </a:spcAft>
              <a:buFont typeface="Symbol" panose="05050102010706020507" pitchFamily="18" charset="2"/>
              <a:buChar char=""/>
            </a:pP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spite the observed effects of positional changes and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neumoperitoneum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n hemodynamic and cardiac electrical parameters during LSG, most patients tolerated these changes well.</a:t>
            </a:r>
            <a:endParaRPr lang="tr-TR" sz="1200" dirty="0" smtClean="0">
              <a:solidFill>
                <a:srgbClr val="000000"/>
              </a:solidFill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lvl="0" indent="-342900" algn="just">
              <a:lnSpc>
                <a:spcPct val="200000"/>
              </a:lnSpc>
              <a:spcAft>
                <a:spcPts val="800"/>
              </a:spcAft>
              <a:buFont typeface="Symbol" panose="05050102010706020507" pitchFamily="18" charset="2"/>
              <a:buChar char=""/>
            </a:pPr>
            <a:r>
              <a:rPr lang="tr-TR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rdiac </a:t>
            </a:r>
            <a:r>
              <a:rPr lang="tr-TR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lectrophysiological</a:t>
            </a:r>
            <a:r>
              <a:rPr lang="tr-TR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alance</a:t>
            </a:r>
            <a:r>
              <a:rPr lang="tr-TR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dex</a:t>
            </a:r>
            <a:r>
              <a:rPr lang="tr-TR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alues</a:t>
            </a:r>
            <a:r>
              <a:rPr lang="tr-TR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mained</a:t>
            </a:r>
            <a:r>
              <a:rPr lang="tr-TR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ithin</a:t>
            </a:r>
            <a:r>
              <a:rPr lang="tr-TR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</a:t>
            </a:r>
            <a:r>
              <a:rPr lang="tr-TR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normal </a:t>
            </a:r>
            <a:r>
              <a:rPr lang="tr-TR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ange</a:t>
            </a:r>
            <a:r>
              <a:rPr lang="tr-TR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3.14–5.35) </a:t>
            </a:r>
            <a:r>
              <a:rPr lang="tr-TR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roughout</a:t>
            </a:r>
            <a:r>
              <a:rPr lang="tr-TR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</a:t>
            </a:r>
            <a:r>
              <a:rPr lang="tr-TR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ocedure</a:t>
            </a:r>
            <a:r>
              <a:rPr lang="tr-TR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tr-TR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flecting</a:t>
            </a:r>
            <a:r>
              <a:rPr lang="tr-TR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eserved</a:t>
            </a:r>
            <a:r>
              <a:rPr lang="tr-TR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rdiac</a:t>
            </a:r>
            <a:r>
              <a:rPr lang="tr-TR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utonomic</a:t>
            </a:r>
            <a:r>
              <a:rPr lang="tr-TR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gulation</a:t>
            </a:r>
            <a:r>
              <a:rPr lang="tr-TR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endParaRPr lang="tr-TR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228600" marR="0" lvl="0" indent="-22860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endParaRPr kumimoji="0" lang="tr-TR" sz="1200" b="0" i="0" u="none" strike="noStrike" kern="1200" cap="none" spc="0" normalizeH="0" baseline="0" noProof="0" dirty="0" smtClean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aphicFrame>
        <p:nvGraphicFramePr>
          <p:cNvPr id="51" name="Tablo 5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42798077"/>
              </p:ext>
            </p:extLst>
          </p:nvPr>
        </p:nvGraphicFramePr>
        <p:xfrm>
          <a:off x="4060203" y="1528897"/>
          <a:ext cx="4168256" cy="1536039"/>
        </p:xfrm>
        <a:graphic>
          <a:graphicData uri="http://schemas.openxmlformats.org/drawingml/2006/table">
            <a:tbl>
              <a:tblPr firstRow="1" firstCol="1" bandRow="1"/>
              <a:tblGrid>
                <a:gridCol w="361362">
                  <a:extLst>
                    <a:ext uri="{9D8B030D-6E8A-4147-A177-3AD203B41FA5}">
                      <a16:colId xmlns:a16="http://schemas.microsoft.com/office/drawing/2014/main" val="2976224111"/>
                    </a:ext>
                  </a:extLst>
                </a:gridCol>
                <a:gridCol w="789876">
                  <a:extLst>
                    <a:ext uri="{9D8B030D-6E8A-4147-A177-3AD203B41FA5}">
                      <a16:colId xmlns:a16="http://schemas.microsoft.com/office/drawing/2014/main" val="2410785334"/>
                    </a:ext>
                  </a:extLst>
                </a:gridCol>
                <a:gridCol w="732929">
                  <a:extLst>
                    <a:ext uri="{9D8B030D-6E8A-4147-A177-3AD203B41FA5}">
                      <a16:colId xmlns:a16="http://schemas.microsoft.com/office/drawing/2014/main" val="1725841543"/>
                    </a:ext>
                  </a:extLst>
                </a:gridCol>
                <a:gridCol w="732929">
                  <a:extLst>
                    <a:ext uri="{9D8B030D-6E8A-4147-A177-3AD203B41FA5}">
                      <a16:colId xmlns:a16="http://schemas.microsoft.com/office/drawing/2014/main" val="1275306257"/>
                    </a:ext>
                  </a:extLst>
                </a:gridCol>
                <a:gridCol w="732929">
                  <a:extLst>
                    <a:ext uri="{9D8B030D-6E8A-4147-A177-3AD203B41FA5}">
                      <a16:colId xmlns:a16="http://schemas.microsoft.com/office/drawing/2014/main" val="39088754"/>
                    </a:ext>
                  </a:extLst>
                </a:gridCol>
                <a:gridCol w="818231">
                  <a:extLst>
                    <a:ext uri="{9D8B030D-6E8A-4147-A177-3AD203B41FA5}">
                      <a16:colId xmlns:a16="http://schemas.microsoft.com/office/drawing/2014/main" val="3025812927"/>
                    </a:ext>
                  </a:extLst>
                </a:gridCol>
              </a:tblGrid>
              <a:tr h="31290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tr-TR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tr-TR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tr-TR" sz="8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-</a:t>
                      </a:r>
                      <a:r>
                        <a:rPr lang="tr-TR" sz="8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aseline</a:t>
                      </a:r>
                      <a:endParaRPr lang="tr-TR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tr-TR" sz="8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1</a:t>
                      </a:r>
                      <a:endParaRPr lang="tr-TR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tr-TR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2</a:t>
                      </a:r>
                      <a:endParaRPr lang="tr-TR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tr-TR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3</a:t>
                      </a:r>
                      <a:endParaRPr lang="tr-TR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tr-TR" sz="8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4</a:t>
                      </a:r>
                      <a:endParaRPr lang="tr-TR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39448075"/>
                  </a:ext>
                </a:extLst>
              </a:tr>
              <a:tr h="31290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tr-TR" sz="8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AP</a:t>
                      </a:r>
                      <a:endParaRPr lang="tr-TR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tr-TR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36.56 ± 2.36</a:t>
                      </a:r>
                      <a:r>
                        <a:rPr lang="tr-TR" sz="800" baseline="30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</a:t>
                      </a:r>
                      <a:endParaRPr lang="tr-TR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tr-TR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09.53±1.64</a:t>
                      </a:r>
                      <a:r>
                        <a:rPr lang="tr-TR" sz="800" baseline="300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,b</a:t>
                      </a:r>
                      <a:endParaRPr lang="tr-TR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tr-TR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17.79±2.64</a:t>
                      </a:r>
                      <a:r>
                        <a:rPr lang="tr-TR" sz="800" baseline="300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,b</a:t>
                      </a:r>
                      <a:endParaRPr lang="tr-TR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tr-TR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12.83 ± 2.93</a:t>
                      </a:r>
                      <a:r>
                        <a:rPr lang="tr-TR" sz="800" baseline="30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</a:t>
                      </a:r>
                      <a:endParaRPr lang="tr-TR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tr-TR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18.83 ± 1.64</a:t>
                      </a:r>
                      <a:r>
                        <a:rPr lang="tr-TR" sz="800" baseline="30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,b</a:t>
                      </a:r>
                      <a:endParaRPr lang="tr-TR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08120000"/>
                  </a:ext>
                </a:extLst>
              </a:tr>
              <a:tr h="31290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tr-TR" sz="8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AP</a:t>
                      </a:r>
                      <a:endParaRPr lang="tr-TR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tr-TR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4.09 ± 1.63</a:t>
                      </a:r>
                      <a:r>
                        <a:rPr lang="tr-TR" sz="800" baseline="30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</a:t>
                      </a:r>
                      <a:endParaRPr lang="tr-TR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tr-TR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65.20 ± 1.25</a:t>
                      </a:r>
                      <a:r>
                        <a:rPr lang="tr-TR" sz="800" baseline="30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</a:t>
                      </a:r>
                      <a:endParaRPr lang="tr-TR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tr-TR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66.379 ± 1.72</a:t>
                      </a:r>
                      <a:r>
                        <a:rPr lang="tr-TR" sz="800" baseline="30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</a:t>
                      </a:r>
                      <a:endParaRPr lang="tr-TR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tr-TR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64.500 ± 1.92</a:t>
                      </a:r>
                      <a:r>
                        <a:rPr lang="tr-TR" sz="800" baseline="30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</a:t>
                      </a:r>
                      <a:endParaRPr lang="tr-TR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tr-TR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63.73 ± 1.18</a:t>
                      </a:r>
                      <a:r>
                        <a:rPr lang="tr-TR" sz="800" baseline="30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</a:t>
                      </a:r>
                      <a:endParaRPr lang="tr-TR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31606552"/>
                  </a:ext>
                </a:extLst>
              </a:tr>
              <a:tr h="31290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tr-TR" sz="8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AP</a:t>
                      </a:r>
                      <a:endParaRPr lang="tr-TR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tr-TR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98.70 ± 1.86</a:t>
                      </a:r>
                      <a:r>
                        <a:rPr lang="tr-TR" sz="800" baseline="30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</a:t>
                      </a:r>
                      <a:endParaRPr lang="tr-TR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tr-TR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82.08 ± 1.35</a:t>
                      </a:r>
                      <a:r>
                        <a:rPr lang="tr-TR" sz="800" baseline="30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</a:t>
                      </a:r>
                      <a:endParaRPr lang="tr-TR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tr-TR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85.76 ± 1.92</a:t>
                      </a:r>
                      <a:r>
                        <a:rPr lang="tr-TR" sz="800" baseline="30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</a:t>
                      </a:r>
                      <a:endParaRPr lang="tr-TR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tr-TR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82.73 ± 2.26</a:t>
                      </a:r>
                      <a:r>
                        <a:rPr lang="tr-TR" sz="800" baseline="30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</a:t>
                      </a:r>
                      <a:endParaRPr lang="tr-TR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tr-TR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84.86 ± 1.23</a:t>
                      </a:r>
                      <a:r>
                        <a:rPr lang="tr-TR" sz="800" baseline="30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</a:t>
                      </a:r>
                      <a:endParaRPr lang="tr-TR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17367804"/>
                  </a:ext>
                </a:extLst>
              </a:tr>
              <a:tr h="284435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tr-TR" sz="8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R</a:t>
                      </a:r>
                      <a:endParaRPr lang="tr-TR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tr-TR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83.92 ± 1.64</a:t>
                      </a:r>
                      <a:r>
                        <a:rPr lang="tr-TR" sz="800" baseline="30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</a:t>
                      </a:r>
                      <a:endParaRPr lang="tr-TR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tr-TR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7.70 ± 1.68</a:t>
                      </a:r>
                      <a:r>
                        <a:rPr lang="tr-TR" sz="800" baseline="30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,b</a:t>
                      </a:r>
                      <a:endParaRPr lang="tr-TR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tr-TR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88.20 </a:t>
                      </a:r>
                      <a:r>
                        <a:rPr lang="tr-TR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±1.59</a:t>
                      </a:r>
                      <a:r>
                        <a:rPr lang="tr-TR" sz="800" baseline="300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,d</a:t>
                      </a:r>
                      <a:endParaRPr lang="tr-TR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tr-TR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84.55 ± 1.58</a:t>
                      </a:r>
                      <a:r>
                        <a:rPr lang="tr-TR" sz="800" baseline="30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</a:t>
                      </a:r>
                      <a:endParaRPr lang="tr-TR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tr-TR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82.21 ± 1.65</a:t>
                      </a:r>
                      <a:r>
                        <a:rPr lang="tr-TR" sz="800" baseline="30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</a:t>
                      </a:r>
                      <a:endParaRPr lang="tr-TR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33045681"/>
                  </a:ext>
                </a:extLst>
              </a:tr>
            </a:tbl>
          </a:graphicData>
        </a:graphic>
      </p:graphicFrame>
      <p:graphicFrame>
        <p:nvGraphicFramePr>
          <p:cNvPr id="55" name="İçerik Yer Tutucusu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93905749"/>
              </p:ext>
            </p:extLst>
          </p:nvPr>
        </p:nvGraphicFramePr>
        <p:xfrm>
          <a:off x="4292852" y="3161565"/>
          <a:ext cx="3705225" cy="22325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</p:spTree>
    <p:extLst>
      <p:ext uri="{BB962C8B-B14F-4D97-AF65-F5344CB8AC3E}">
        <p14:creationId xmlns:p14="http://schemas.microsoft.com/office/powerpoint/2010/main" val="12190689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60</TotalTime>
  <Words>236</Words>
  <Application>Microsoft Office PowerPoint</Application>
  <PresentationFormat>Geniş ekran</PresentationFormat>
  <Paragraphs>51</Paragraphs>
  <Slides>1</Slides>
  <Notes>1</Notes>
  <HiddenSlides>0</HiddenSlides>
  <MMClips>0</MMClips>
  <ScaleCrop>false</ScaleCrop>
  <HeadingPairs>
    <vt:vector size="6" baseType="variant">
      <vt:variant>
        <vt:lpstr>Kullanılan Yazı Tipleri</vt:lpstr>
      </vt:variant>
      <vt:variant>
        <vt:i4>5</vt:i4>
      </vt:variant>
      <vt:variant>
        <vt:lpstr>Tema</vt:lpstr>
      </vt:variant>
      <vt:variant>
        <vt:i4>1</vt:i4>
      </vt:variant>
      <vt:variant>
        <vt:lpstr>Slayt Başlıkları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imes New Roman</vt:lpstr>
      <vt:lpstr>Tema di Office</vt:lpstr>
      <vt:lpstr>PowerPoint Sunusu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.mazzarella</dc:creator>
  <cp:lastModifiedBy>Fatma Sevinc Celik</cp:lastModifiedBy>
  <cp:revision>133</cp:revision>
  <dcterms:created xsi:type="dcterms:W3CDTF">2017-10-03T08:27:08Z</dcterms:created>
  <dcterms:modified xsi:type="dcterms:W3CDTF">2025-06-15T07:31:28Z</dcterms:modified>
</cp:coreProperties>
</file>